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_tradnl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napVertSplitter="1" vertBarState="minimized" horzBarState="maximized">
    <p:restoredLeft sz="15620"/>
    <p:restoredTop sz="94660"/>
  </p:normalViewPr>
  <p:slideViewPr>
    <p:cSldViewPr snapToGrid="0" snapToObjects="1">
      <p:cViewPr>
        <p:scale>
          <a:sx n="75" d="100"/>
          <a:sy n="75" d="100"/>
        </p:scale>
        <p:origin x="-1856" y="-5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5E638-97B0-8147-97EE-2E42EE41E2FE}" type="datetimeFigureOut">
              <a:rPr lang="es-ES_tradnl" smtClean="0"/>
              <a:t>13/8/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6E1D-8DE2-8443-B842-E86788C1CA5C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5E638-97B0-8147-97EE-2E42EE41E2FE}" type="datetimeFigureOut">
              <a:rPr lang="es-ES_tradnl" smtClean="0"/>
              <a:t>13/8/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6E1D-8DE2-8443-B842-E86788C1CA5C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5E638-97B0-8147-97EE-2E42EE41E2FE}" type="datetimeFigureOut">
              <a:rPr lang="es-ES_tradnl" smtClean="0"/>
              <a:t>13/8/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6E1D-8DE2-8443-B842-E86788C1CA5C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5E638-97B0-8147-97EE-2E42EE41E2FE}" type="datetimeFigureOut">
              <a:rPr lang="es-ES_tradnl" smtClean="0"/>
              <a:t>13/8/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6E1D-8DE2-8443-B842-E86788C1CA5C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5E638-97B0-8147-97EE-2E42EE41E2FE}" type="datetimeFigureOut">
              <a:rPr lang="es-ES_tradnl" smtClean="0"/>
              <a:t>13/8/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6E1D-8DE2-8443-B842-E86788C1CA5C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5E638-97B0-8147-97EE-2E42EE41E2FE}" type="datetimeFigureOut">
              <a:rPr lang="es-ES_tradnl" smtClean="0"/>
              <a:t>13/8/19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6E1D-8DE2-8443-B842-E86788C1CA5C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5E638-97B0-8147-97EE-2E42EE41E2FE}" type="datetimeFigureOut">
              <a:rPr lang="es-ES_tradnl" smtClean="0"/>
              <a:t>13/8/19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6E1D-8DE2-8443-B842-E86788C1CA5C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5E638-97B0-8147-97EE-2E42EE41E2FE}" type="datetimeFigureOut">
              <a:rPr lang="es-ES_tradnl" smtClean="0"/>
              <a:t>13/8/19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6E1D-8DE2-8443-B842-E86788C1CA5C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5E638-97B0-8147-97EE-2E42EE41E2FE}" type="datetimeFigureOut">
              <a:rPr lang="es-ES_tradnl" smtClean="0"/>
              <a:t>13/8/19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6E1D-8DE2-8443-B842-E86788C1CA5C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5E638-97B0-8147-97EE-2E42EE41E2FE}" type="datetimeFigureOut">
              <a:rPr lang="es-ES_tradnl" smtClean="0"/>
              <a:t>13/8/19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6E1D-8DE2-8443-B842-E86788C1CA5C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5E638-97B0-8147-97EE-2E42EE41E2FE}" type="datetimeFigureOut">
              <a:rPr lang="es-ES_tradnl" smtClean="0"/>
              <a:t>13/8/19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6E1D-8DE2-8443-B842-E86788C1CA5C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55E638-97B0-8147-97EE-2E42EE41E2FE}" type="datetimeFigureOut">
              <a:rPr lang="es-ES_tradnl" smtClean="0"/>
              <a:t>13/8/19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A6E1D-8DE2-8443-B842-E86788C1CA5C}" type="slidenum">
              <a:rPr lang="en-US" smtClean="0"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8" Type="http://schemas.openxmlformats.org/officeDocument/2006/relationships/image" Target="../media/image7.jpeg"/><Relationship Id="rId9" Type="http://schemas.openxmlformats.org/officeDocument/2006/relationships/image" Target="../media/image8.jpeg"/><Relationship Id="rId10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 descr="export-screen-2019-Aug-12_1334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28172" y="1178143"/>
            <a:ext cx="2570451" cy="1290975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5" name="Imagen 4" descr="export-screen-2019-Aug-12_1335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28172" y="2469118"/>
            <a:ext cx="2570451" cy="1312001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6" name="Imagen 5" descr="export-screen-2019-Aug-12_1340.jp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57721" y="2469117"/>
            <a:ext cx="2570451" cy="1312001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7" name="Imagen 6" descr="export-screen-2019-Aug-13_0812.jpg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28172" y="3781118"/>
            <a:ext cx="2570451" cy="1306340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9" name="Imagen 8" descr="export-screen-2019-Aug-13_0814.jpg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57722" y="3781119"/>
            <a:ext cx="2570450" cy="1306339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10" name="Imagen 9" descr="export-screen-2019-Aug-13_0817.jpg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7499" y="2469118"/>
            <a:ext cx="2540221" cy="1290976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11" name="Imagen 10" descr="export-screen-2019-Aug-13_0819.jpg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7498" y="3760094"/>
            <a:ext cx="2540221" cy="1327364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12" name="Imagen 11" descr="export-screen-2019-Aug-13_0820.jpg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7499" y="1178143"/>
            <a:ext cx="2540220" cy="1290976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14" name="Imagen 13" descr="export-screen-2019-Aug-13_0828.jpg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57719" y="1178142"/>
            <a:ext cx="2570453" cy="1290977"/>
          </a:xfrm>
          <a:prstGeom prst="rect">
            <a:avLst/>
          </a:prstGeom>
          <a:ln>
            <a:solidFill>
              <a:srgbClr val="FFFFFF"/>
            </a:solidFill>
          </a:ln>
        </p:spPr>
      </p:pic>
      <p:sp>
        <p:nvSpPr>
          <p:cNvPr id="15" name="CuadroTexto 14"/>
          <p:cNvSpPr txBox="1"/>
          <p:nvPr/>
        </p:nvSpPr>
        <p:spPr>
          <a:xfrm>
            <a:off x="317499" y="907911"/>
            <a:ext cx="76811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	LOW						INTERMEDIATE				HIGH</a:t>
            </a:r>
            <a:endParaRPr lang="en-US" sz="1400" dirty="0"/>
          </a:p>
        </p:txBody>
      </p:sp>
      <p:sp>
        <p:nvSpPr>
          <p:cNvPr id="16" name="CuadroTexto 15"/>
          <p:cNvSpPr txBox="1"/>
          <p:nvPr/>
        </p:nvSpPr>
        <p:spPr>
          <a:xfrm>
            <a:off x="636014" y="5503333"/>
            <a:ext cx="8169319" cy="92333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SUPPL FIGURE 1.- Intensity of the inflammatory infiltrate scored from low to intermediate and high. Eosinophilic scars are frequently associated with high inflammatory infiltrate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41</Words>
  <Application>Microsoft Macintosh PowerPoint</Application>
  <PresentationFormat>Presentación en pantalla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Plantilla de diseño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CNIO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iguel Ángel Piris</dc:creator>
  <cp:lastModifiedBy>Miguel Ángel Piris</cp:lastModifiedBy>
  <cp:revision>1</cp:revision>
  <dcterms:created xsi:type="dcterms:W3CDTF">2019-08-13T06:30:19Z</dcterms:created>
  <dcterms:modified xsi:type="dcterms:W3CDTF">2019-08-13T06:50:53Z</dcterms:modified>
</cp:coreProperties>
</file>